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6119813" cy="79200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>
        <p:scale>
          <a:sx n="90" d="100"/>
          <a:sy n="90" d="100"/>
        </p:scale>
        <p:origin x="1476" y="-12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296173"/>
            <a:ext cx="5201841" cy="2757347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159854"/>
            <a:ext cx="4589860" cy="1912175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6203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87603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21669"/>
            <a:ext cx="1319585" cy="671186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21669"/>
            <a:ext cx="3882256" cy="671186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74884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2063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1974512"/>
            <a:ext cx="5278339" cy="3294515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300194"/>
            <a:ext cx="5278339" cy="1732508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1120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108344"/>
            <a:ext cx="2600921" cy="502519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108344"/>
            <a:ext cx="2600921" cy="502519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5610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21671"/>
            <a:ext cx="5278339" cy="153084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941510"/>
            <a:ext cx="2588967" cy="95150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2893014"/>
            <a:ext cx="2588967" cy="42551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941510"/>
            <a:ext cx="2601718" cy="95150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2893014"/>
            <a:ext cx="2601718" cy="42551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1975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1633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1636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28002"/>
            <a:ext cx="1973799" cy="1848009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40341"/>
            <a:ext cx="3098155" cy="5628360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376011"/>
            <a:ext cx="1973799" cy="440185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94052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28002"/>
            <a:ext cx="1973799" cy="1848009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40341"/>
            <a:ext cx="3098155" cy="5628360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376011"/>
            <a:ext cx="1973799" cy="440185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88252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21671"/>
            <a:ext cx="5278339" cy="15308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108344"/>
            <a:ext cx="5278339" cy="50251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340703"/>
            <a:ext cx="1376958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340703"/>
            <a:ext cx="2065437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340703"/>
            <a:ext cx="1376958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79401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43F2706-AFD9-48AE-B25C-6AA2BDE34C45}"/>
              </a:ext>
            </a:extLst>
          </p:cNvPr>
          <p:cNvSpPr txBox="1"/>
          <p:nvPr/>
        </p:nvSpPr>
        <p:spPr>
          <a:xfrm>
            <a:off x="254272" y="6002921"/>
            <a:ext cx="5673441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MGB1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itical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CP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hancing epithelial mesenchymal transformation (EMT) in HCC cells. 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, B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uh7 cells were transfected by VCP-siRNA and exogenous HMGB1. Meanwhile, MHCC-LM3 cells were treated with exogenous VCP and HMGB1-siRNA. Western blot was operated to determine the protein expression of  biomarkers relevant to EMT, and the gray density was further analyzed. Al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* P＜0.05, ** P ＜0.01, *** P ＜0.001 , and **** P ＜0.0001.</a:t>
            </a:r>
          </a:p>
        </p:txBody>
      </p:sp>
      <p:pic>
        <p:nvPicPr>
          <p:cNvPr id="3" name="Picture 2" descr="A picture containing text, writing implement, stationary, pencil&#10;&#10;Description automatically generated">
            <a:extLst>
              <a:ext uri="{FF2B5EF4-FFF2-40B4-BE49-F238E27FC236}">
                <a16:creationId xmlns:a16="http://schemas.microsoft.com/office/drawing/2014/main" id="{38A88055-93AD-4010-BE2B-DC920A04E8E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9242" y="435562"/>
            <a:ext cx="5830571" cy="55008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11500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6</TotalTime>
  <Words>89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雅 意天空</dc:creator>
  <cp:lastModifiedBy>雅 意天空</cp:lastModifiedBy>
  <cp:revision>9</cp:revision>
  <dcterms:created xsi:type="dcterms:W3CDTF">2022-04-15T05:49:56Z</dcterms:created>
  <dcterms:modified xsi:type="dcterms:W3CDTF">2022-04-20T15:18:57Z</dcterms:modified>
</cp:coreProperties>
</file>